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9" r:id="rId2"/>
  </p:sldIdLst>
  <p:sldSz cx="12192000" cy="6858000"/>
  <p:notesSz cx="9926638" cy="6797675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33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446" autoAdjust="0"/>
    <p:restoredTop sz="94660"/>
  </p:normalViewPr>
  <p:slideViewPr>
    <p:cSldViewPr snapToGrid="0">
      <p:cViewPr>
        <p:scale>
          <a:sx n="70" d="100"/>
          <a:sy n="70" d="100"/>
        </p:scale>
        <p:origin x="-432" y="-9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\\bd-7-ivrb28\SHARE%20LAB\maya\&#1490;&#1493;&#1491;&#1500;%20&#1496;&#1497;&#1508;&#1493;&#1514;%20&#1513;&#1502;&#1503;+&#1510;&#1508;&#1497;&#1508;&#1493;&#1514;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\\bd-7-ivrb28\SHARE%20LAB\maya\&#1490;&#1493;&#1491;&#1500;%20&#1496;&#1497;&#1508;&#1493;&#1514;%20&#1513;&#1502;&#1503;+&#1510;&#1508;&#1497;&#1508;&#1493;&#1514;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\\bd-7-ivrb28\SHARE%20LAB\maya\&#1514;&#1493;&#1510;&#1488;&#1493;&#1514;-&#1490;&#1493;&#1491;&#1500;%20&#1496;&#1497;&#1508;&#1493;&#1514;%20HPLC;GC\&#1490;&#1493;&#1491;&#1500;%20&#1496;&#1497;&#1508;&#1493;&#1514;%20&#1513;&#1502;&#1503;+&#1510;&#1508;&#1497;&#1508;&#1493;&#151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08C-4A62-A732-C9FABBA6A897}"/>
              </c:ext>
            </c:extLst>
          </c:dPt>
          <c:dPt>
            <c:idx val="1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A-14A2-43CD-93FC-63ACDF1469F5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08C-4A62-A732-C9FABBA6A897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14A2-43CD-93FC-63ACDF1469F5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08C-4A62-A732-C9FABBA6A897}"/>
              </c:ext>
            </c:extLst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C-14A2-43CD-93FC-63ACDF1469F5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08C-4A62-A732-C9FABBA6A897}"/>
              </c:ext>
            </c:extLst>
          </c:dPt>
          <c:dPt>
            <c:idx val="1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14A2-43CD-93FC-63ACDF1469F5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008C-4A62-A732-C9FABBA6A897}"/>
              </c:ext>
            </c:extLst>
          </c:dPt>
          <c:dPt>
            <c:idx val="13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E-14A2-43CD-93FC-63ACDF1469F5}"/>
              </c:ext>
            </c:extLst>
          </c:dPt>
          <c:errBars>
            <c:errBarType val="both"/>
            <c:errValType val="cust"/>
            <c:noEndCap val="0"/>
            <c:plus>
              <c:numRef>
                <c:f>September!$F$21:$F$34</c:f>
                <c:numCache>
                  <c:formatCode>General</c:formatCode>
                  <c:ptCount val="14"/>
                  <c:pt idx="0">
                    <c:v>80.240999999999985</c:v>
                  </c:pt>
                  <c:pt idx="1">
                    <c:v>80.249000000000024</c:v>
                  </c:pt>
                  <c:pt idx="3">
                    <c:v>185.31799999999998</c:v>
                  </c:pt>
                  <c:pt idx="4">
                    <c:v>185.322</c:v>
                  </c:pt>
                  <c:pt idx="6">
                    <c:v>113.03899999999987</c:v>
                  </c:pt>
                  <c:pt idx="7">
                    <c:v>112.98199999999997</c:v>
                  </c:pt>
                  <c:pt idx="9">
                    <c:v>232.83300000000008</c:v>
                  </c:pt>
                  <c:pt idx="10">
                    <c:v>232.80399999999997</c:v>
                  </c:pt>
                  <c:pt idx="12">
                    <c:v>223.89599999999996</c:v>
                  </c:pt>
                  <c:pt idx="13">
                    <c:v>223.98000000000013</c:v>
                  </c:pt>
                </c:numCache>
              </c:numRef>
            </c:plus>
            <c:minus>
              <c:numRef>
                <c:f>September!$F$21:$F$34</c:f>
                <c:numCache>
                  <c:formatCode>General</c:formatCode>
                  <c:ptCount val="14"/>
                  <c:pt idx="0">
                    <c:v>80.240999999999985</c:v>
                  </c:pt>
                  <c:pt idx="1">
                    <c:v>80.249000000000024</c:v>
                  </c:pt>
                  <c:pt idx="3">
                    <c:v>185.31799999999998</c:v>
                  </c:pt>
                  <c:pt idx="4">
                    <c:v>185.322</c:v>
                  </c:pt>
                  <c:pt idx="6">
                    <c:v>113.03899999999987</c:v>
                  </c:pt>
                  <c:pt idx="7">
                    <c:v>112.98199999999997</c:v>
                  </c:pt>
                  <c:pt idx="9">
                    <c:v>232.83300000000008</c:v>
                  </c:pt>
                  <c:pt idx="10">
                    <c:v>232.80399999999997</c:v>
                  </c:pt>
                  <c:pt idx="12">
                    <c:v>223.89599999999996</c:v>
                  </c:pt>
                  <c:pt idx="13">
                    <c:v>223.980000000000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ptember!$C$21:$C$34</c:f>
              <c:strCache>
                <c:ptCount val="14"/>
                <c:pt idx="0">
                  <c:v>Barnea_Tirat Zvi</c:v>
                </c:pt>
                <c:pt idx="1">
                  <c:v>Barnea_Tzuba</c:v>
                </c:pt>
                <c:pt idx="3">
                  <c:v>Picholine_Tirat Zvi</c:v>
                </c:pt>
                <c:pt idx="4">
                  <c:v>Picholine_Tzuba</c:v>
                </c:pt>
                <c:pt idx="6">
                  <c:v>Koroneiki_Tirat Zvi</c:v>
                </c:pt>
                <c:pt idx="7">
                  <c:v>Koroneiki_Tzuba</c:v>
                </c:pt>
                <c:pt idx="9">
                  <c:v>Souri_Tirat Zvi</c:v>
                </c:pt>
                <c:pt idx="10">
                  <c:v>Souri_Tzuba</c:v>
                </c:pt>
                <c:pt idx="12">
                  <c:v>Coratina_Tirat Zvi</c:v>
                </c:pt>
                <c:pt idx="13">
                  <c:v>Coratina_Tzuba</c:v>
                </c:pt>
              </c:strCache>
            </c:strRef>
          </c:cat>
          <c:val>
            <c:numRef>
              <c:f>September!$E$21:$E$34</c:f>
              <c:numCache>
                <c:formatCode>General</c:formatCode>
                <c:ptCount val="14"/>
                <c:pt idx="0">
                  <c:v>645.43899999999996</c:v>
                </c:pt>
                <c:pt idx="1">
                  <c:v>677.71100000000001</c:v>
                </c:pt>
                <c:pt idx="3">
                  <c:v>591.65200000000004</c:v>
                </c:pt>
                <c:pt idx="4">
                  <c:v>570.13800000000003</c:v>
                </c:pt>
                <c:pt idx="6">
                  <c:v>917.06100000000004</c:v>
                </c:pt>
                <c:pt idx="7">
                  <c:v>650.81799999999998</c:v>
                </c:pt>
                <c:pt idx="9">
                  <c:v>814.86699999999996</c:v>
                </c:pt>
                <c:pt idx="10">
                  <c:v>656.19600000000003</c:v>
                </c:pt>
                <c:pt idx="12">
                  <c:v>502.904</c:v>
                </c:pt>
                <c:pt idx="13">
                  <c:v>801.4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008C-4A62-A732-C9FABBA6A8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3"/>
        <c:axId val="39196544"/>
        <c:axId val="39198080"/>
      </c:barChart>
      <c:catAx>
        <c:axId val="39196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198080"/>
        <c:crosses val="autoZero"/>
        <c:auto val="1"/>
        <c:lblAlgn val="ctr"/>
        <c:lblOffset val="100"/>
        <c:noMultiLvlLbl val="0"/>
      </c:catAx>
      <c:valAx>
        <c:axId val="391980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oil drops in cm</a:t>
                </a:r>
                <a:r>
                  <a:rPr lang="en-US" sz="1400" b="1" i="0" baseline="3000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he-IL" sz="11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8052976670325358E-2"/>
              <c:y val="0.13326145676394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1965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8EC-46FE-B670-0D0FD15EC5A8}"/>
              </c:ext>
            </c:extLst>
          </c:dPt>
          <c:dPt>
            <c:idx val="1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E-54C7-49FB-BC4C-B59D526FA296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8EC-46FE-B670-0D0FD15EC5A8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54C7-49FB-BC4C-B59D526FA296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58EC-46FE-B670-0D0FD15EC5A8}"/>
              </c:ext>
            </c:extLst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C-54C7-49FB-BC4C-B59D526FA296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58EC-46FE-B670-0D0FD15EC5A8}"/>
              </c:ext>
            </c:extLst>
          </c:dPt>
          <c:dPt>
            <c:idx val="1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54C7-49FB-BC4C-B59D526FA296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58EC-46FE-B670-0D0FD15EC5A8}"/>
              </c:ext>
            </c:extLst>
          </c:dPt>
          <c:dPt>
            <c:idx val="13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A-54C7-49FB-BC4C-B59D526FA296}"/>
              </c:ext>
            </c:extLst>
          </c:dPt>
          <c:errBars>
            <c:errBarType val="both"/>
            <c:errValType val="cust"/>
            <c:noEndCap val="0"/>
            <c:plus>
              <c:numRef>
                <c:f>'אחוז שמן רטוב'!$U$20:$U$33</c:f>
                <c:numCache>
                  <c:formatCode>General</c:formatCode>
                  <c:ptCount val="14"/>
                  <c:pt idx="0">
                    <c:v>0.66520000000000046</c:v>
                  </c:pt>
                  <c:pt idx="1">
                    <c:v>0.66479999999999961</c:v>
                  </c:pt>
                  <c:pt idx="3">
                    <c:v>0.83699999999999974</c:v>
                  </c:pt>
                  <c:pt idx="4">
                    <c:v>0.83760000000000012</c:v>
                  </c:pt>
                  <c:pt idx="6">
                    <c:v>1.9829999999999988</c:v>
                  </c:pt>
                  <c:pt idx="7">
                    <c:v>1.9823999999999984</c:v>
                  </c:pt>
                  <c:pt idx="9">
                    <c:v>1.6958000000000002</c:v>
                  </c:pt>
                  <c:pt idx="10">
                    <c:v>1.695999999999998</c:v>
                  </c:pt>
                  <c:pt idx="12">
                    <c:v>1.6109999999999989</c:v>
                  </c:pt>
                  <c:pt idx="13">
                    <c:v>1.6109999999999971</c:v>
                  </c:pt>
                </c:numCache>
              </c:numRef>
            </c:plus>
            <c:minus>
              <c:numRef>
                <c:f>'אחוז שמן רטוב'!$U$20:$U$33</c:f>
                <c:numCache>
                  <c:formatCode>General</c:formatCode>
                  <c:ptCount val="14"/>
                  <c:pt idx="0">
                    <c:v>0.66520000000000046</c:v>
                  </c:pt>
                  <c:pt idx="1">
                    <c:v>0.66479999999999961</c:v>
                  </c:pt>
                  <c:pt idx="3">
                    <c:v>0.83699999999999974</c:v>
                  </c:pt>
                  <c:pt idx="4">
                    <c:v>0.83760000000000012</c:v>
                  </c:pt>
                  <c:pt idx="6">
                    <c:v>1.9829999999999988</c:v>
                  </c:pt>
                  <c:pt idx="7">
                    <c:v>1.9823999999999984</c:v>
                  </c:pt>
                  <c:pt idx="9">
                    <c:v>1.6958000000000002</c:v>
                  </c:pt>
                  <c:pt idx="10">
                    <c:v>1.695999999999998</c:v>
                  </c:pt>
                  <c:pt idx="12">
                    <c:v>1.6109999999999989</c:v>
                  </c:pt>
                  <c:pt idx="13">
                    <c:v>1.61099999999999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אחוז שמן רטוב'!$S$20:$S$33</c:f>
              <c:strCache>
                <c:ptCount val="14"/>
                <c:pt idx="0">
                  <c:v>Barnea_Tirat Zvi</c:v>
                </c:pt>
                <c:pt idx="1">
                  <c:v>Barnea_Tzuba</c:v>
                </c:pt>
                <c:pt idx="3">
                  <c:v>Picholine_Tirat Zvi</c:v>
                </c:pt>
                <c:pt idx="4">
                  <c:v>Picholine_Tzuba</c:v>
                </c:pt>
                <c:pt idx="6">
                  <c:v>Koroneiki_Tirat Zvi</c:v>
                </c:pt>
                <c:pt idx="7">
                  <c:v>Koroneiki_Tzuba</c:v>
                </c:pt>
                <c:pt idx="9">
                  <c:v>Souri_Tirat Zvi</c:v>
                </c:pt>
                <c:pt idx="10">
                  <c:v>Souri_Tzuba</c:v>
                </c:pt>
                <c:pt idx="12">
                  <c:v>Coratina_Tirat Zvi</c:v>
                </c:pt>
                <c:pt idx="13">
                  <c:v>Coratina_Tzuba</c:v>
                </c:pt>
              </c:strCache>
            </c:strRef>
          </c:cat>
          <c:val>
            <c:numRef>
              <c:f>'אחוז שמן רטוב'!$T$20:$T$33</c:f>
              <c:numCache>
                <c:formatCode>0.000</c:formatCode>
                <c:ptCount val="14"/>
                <c:pt idx="0" formatCode="General">
                  <c:v>11.404864639349922</c:v>
                </c:pt>
                <c:pt idx="1">
                  <c:v>16.381104129142606</c:v>
                </c:pt>
                <c:pt idx="2" formatCode="General">
                  <c:v>0</c:v>
                </c:pt>
                <c:pt idx="3" formatCode="General">
                  <c:v>7.4803259560310007</c:v>
                </c:pt>
                <c:pt idx="4" formatCode="General">
                  <c:v>11.509375589591354</c:v>
                </c:pt>
                <c:pt idx="5" formatCode="General">
                  <c:v>0</c:v>
                </c:pt>
                <c:pt idx="6" formatCode="General">
                  <c:v>8.8899963392993762</c:v>
                </c:pt>
                <c:pt idx="7" formatCode="General">
                  <c:v>18.783543209511585</c:v>
                </c:pt>
                <c:pt idx="8" formatCode="General">
                  <c:v>0</c:v>
                </c:pt>
                <c:pt idx="9" formatCode="General">
                  <c:v>10.287863750792805</c:v>
                </c:pt>
                <c:pt idx="10" formatCode="General">
                  <c:v>19.230730603249192</c:v>
                </c:pt>
                <c:pt idx="11" formatCode="General">
                  <c:v>0</c:v>
                </c:pt>
                <c:pt idx="12" formatCode="General">
                  <c:v>12.581886697525711</c:v>
                </c:pt>
                <c:pt idx="13" formatCode="General">
                  <c:v>19.2219932816560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58EC-46FE-B670-0D0FD15EC5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8"/>
        <c:axId val="39329792"/>
        <c:axId val="39331328"/>
      </c:barChart>
      <c:catAx>
        <c:axId val="39329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331328"/>
        <c:crosses val="autoZero"/>
        <c:auto val="1"/>
        <c:lblAlgn val="ctr"/>
        <c:lblOffset val="100"/>
        <c:noMultiLvlLbl val="0"/>
      </c:catAx>
      <c:valAx>
        <c:axId val="393313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il content (%)</a:t>
                </a:r>
                <a:endParaRPr lang="he-IL" sz="8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5759232676756548E-2"/>
              <c:y val="0.1809267516455412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3297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023486839021057"/>
          <c:y val="6.285448444475239E-2"/>
          <c:w val="0.71821508059997363"/>
          <c:h val="0.804589592161231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A71-4682-9DA6-61B814D7DC38}"/>
              </c:ext>
            </c:extLst>
          </c:dPt>
          <c:dPt>
            <c:idx val="1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0A71-4682-9DA6-61B814D7DC38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A71-4682-9DA6-61B814D7DC38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 w="12700" cap="flat" cmpd="sng" algn="ctr">
                <a:solidFill>
                  <a:srgbClr val="0000FF"/>
                </a:solidFill>
                <a:prstDash val="solid"/>
                <a:miter lim="800000"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A71-4682-9DA6-61B814D7DC38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A71-4682-9DA6-61B814D7DC38}"/>
              </c:ext>
            </c:extLst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0-0A71-4682-9DA6-61B814D7DC38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0A71-4682-9DA6-61B814D7DC38}"/>
              </c:ext>
            </c:extLst>
          </c:dPt>
          <c:dPt>
            <c:idx val="10"/>
            <c:invertIfNegative val="0"/>
            <c:bubble3D val="0"/>
            <c:spPr>
              <a:solidFill>
                <a:srgbClr val="0000FF"/>
              </a:solidFill>
              <a:ln w="12700" cap="flat" cmpd="sng" algn="ctr">
                <a:solidFill>
                  <a:srgbClr val="0000FF"/>
                </a:solidFill>
                <a:prstDash val="solid"/>
                <a:miter lim="800000"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0A71-4682-9DA6-61B814D7DC38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0A71-4682-9DA6-61B814D7DC38}"/>
              </c:ext>
            </c:extLst>
          </c:dPt>
          <c:dPt>
            <c:idx val="13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0A71-4682-9DA6-61B814D7DC38}"/>
              </c:ext>
            </c:extLst>
          </c:dPt>
          <c:errBars>
            <c:errBarType val="both"/>
            <c:errValType val="cust"/>
            <c:noEndCap val="0"/>
            <c:plus>
              <c:numRef>
                <c:f>September!$F$3:$F$16</c:f>
                <c:numCache>
                  <c:formatCode>General</c:formatCode>
                  <c:ptCount val="14"/>
                  <c:pt idx="0">
                    <c:v>74.353999999999999</c:v>
                  </c:pt>
                  <c:pt idx="1">
                    <c:v>66.442999999999998</c:v>
                  </c:pt>
                  <c:pt idx="3">
                    <c:v>38.566000000000003</c:v>
                  </c:pt>
                  <c:pt idx="4">
                    <c:v>39.115000000000002</c:v>
                  </c:pt>
                  <c:pt idx="6">
                    <c:v>34.816000000000003</c:v>
                  </c:pt>
                  <c:pt idx="7">
                    <c:v>41.549000000000007</c:v>
                  </c:pt>
                  <c:pt idx="9">
                    <c:v>19.535</c:v>
                  </c:pt>
                  <c:pt idx="10">
                    <c:v>21.454000000000001</c:v>
                  </c:pt>
                  <c:pt idx="12">
                    <c:v>49.189</c:v>
                  </c:pt>
                  <c:pt idx="13">
                    <c:v>39.103000000000101</c:v>
                  </c:pt>
                </c:numCache>
              </c:numRef>
            </c:plus>
            <c:minus>
              <c:numRef>
                <c:f>September!$F$3:$F$16</c:f>
                <c:numCache>
                  <c:formatCode>General</c:formatCode>
                  <c:ptCount val="14"/>
                  <c:pt idx="0">
                    <c:v>74.353999999999999</c:v>
                  </c:pt>
                  <c:pt idx="1">
                    <c:v>66.442999999999998</c:v>
                  </c:pt>
                  <c:pt idx="3">
                    <c:v>38.566000000000003</c:v>
                  </c:pt>
                  <c:pt idx="4">
                    <c:v>39.115000000000002</c:v>
                  </c:pt>
                  <c:pt idx="6">
                    <c:v>34.816000000000003</c:v>
                  </c:pt>
                  <c:pt idx="7">
                    <c:v>41.549000000000007</c:v>
                  </c:pt>
                  <c:pt idx="9">
                    <c:v>19.535</c:v>
                  </c:pt>
                  <c:pt idx="10">
                    <c:v>21.454000000000001</c:v>
                  </c:pt>
                  <c:pt idx="12">
                    <c:v>49.189</c:v>
                  </c:pt>
                  <c:pt idx="13">
                    <c:v>39.1030000000001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ptember!$A$3:$A$15</c:f>
              <c:strCache>
                <c:ptCount val="13"/>
                <c:pt idx="0">
                  <c:v>Barnea</c:v>
                </c:pt>
                <c:pt idx="3">
                  <c:v>Picholine</c:v>
                </c:pt>
                <c:pt idx="6">
                  <c:v>Koroneiki</c:v>
                </c:pt>
                <c:pt idx="9">
                  <c:v>Souri</c:v>
                </c:pt>
                <c:pt idx="12">
                  <c:v>Coratina</c:v>
                </c:pt>
              </c:strCache>
            </c:strRef>
          </c:cat>
          <c:val>
            <c:numRef>
              <c:f>September!$E$3:$E$16</c:f>
              <c:numCache>
                <c:formatCode>General</c:formatCode>
                <c:ptCount val="14"/>
                <c:pt idx="0">
                  <c:v>658.27599999999995</c:v>
                </c:pt>
                <c:pt idx="1">
                  <c:v>859.99999999999989</c:v>
                </c:pt>
                <c:pt idx="3">
                  <c:v>249.334</c:v>
                </c:pt>
                <c:pt idx="4">
                  <c:v>452.20499999999998</c:v>
                </c:pt>
                <c:pt idx="6">
                  <c:v>165.964</c:v>
                </c:pt>
                <c:pt idx="7">
                  <c:v>430.88099999999997</c:v>
                </c:pt>
                <c:pt idx="9">
                  <c:v>98.034999999999997</c:v>
                </c:pt>
                <c:pt idx="10">
                  <c:v>346.42600000000004</c:v>
                </c:pt>
                <c:pt idx="12">
                  <c:v>497.42099999999999</c:v>
                </c:pt>
                <c:pt idx="13">
                  <c:v>583.99699999999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0A71-4682-9DA6-61B814D7DC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9798656"/>
        <c:axId val="39800192"/>
      </c:barChart>
      <c:catAx>
        <c:axId val="39798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800192"/>
        <c:crosses val="autoZero"/>
        <c:auto val="1"/>
        <c:lblAlgn val="ctr"/>
        <c:lblOffset val="100"/>
        <c:noMultiLvlLbl val="0"/>
      </c:catAx>
      <c:valAx>
        <c:axId val="398001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il drop</a:t>
                </a:r>
                <a:r>
                  <a:rPr lang="en-US" sz="1400" b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4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ea (</a:t>
                </a:r>
                <a:r>
                  <a:rPr lang="en-US" sz="1400" b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µ</a:t>
                </a:r>
                <a:r>
                  <a:rPr lang="en-US" sz="1400" b="1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r>
                  <a:rPr lang="en-US" sz="1400" b="1" baseline="3000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sz="1400" b="1" baseline="0" dirty="0" smtClean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he-IL" sz="14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670237725832844E-2"/>
              <c:y val="0.1067008477934530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7986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2798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A8F7B846-B10E-40A5-B4A2-020A834E6BBE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2798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83C229AF-AF85-4F0D-BE1E-953DEBC67F9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0324775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0805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21057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04373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69925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38052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15288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28959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59664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90995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74268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77755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37438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chart" Target="../charts/chart2.xml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0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9.tiff"/><Relationship Id="rId5" Type="http://schemas.openxmlformats.org/officeDocument/2006/relationships/image" Target="../media/image4.tiff"/><Relationship Id="rId10" Type="http://schemas.openxmlformats.org/officeDocument/2006/relationships/chart" Target="../charts/chart1.xml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5514354" y="2935489"/>
            <a:ext cx="1665600" cy="1249200"/>
          </a:xfrm>
          <a:prstGeom prst="rect">
            <a:avLst/>
          </a:prstGeom>
        </p:spPr>
      </p:pic>
      <p:pic>
        <p:nvPicPr>
          <p:cNvPr id="36" name="Pictur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7419" y="2937514"/>
            <a:ext cx="1665600" cy="1249200"/>
          </a:xfrm>
          <a:prstGeom prst="rect">
            <a:avLst/>
          </a:prstGeom>
        </p:spPr>
      </p:pic>
      <p:pic>
        <p:nvPicPr>
          <p:cNvPr id="39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4353" y="5581750"/>
            <a:ext cx="1665600" cy="1249200"/>
          </a:xfrm>
          <a:prstGeom prst="rect">
            <a:avLst/>
          </a:prstGeom>
        </p:spPr>
      </p:pic>
      <p:pic>
        <p:nvPicPr>
          <p:cNvPr id="40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7418" y="5581750"/>
            <a:ext cx="1665600" cy="12492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767418" y="4261432"/>
            <a:ext cx="1665600" cy="12492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4353" y="4296430"/>
            <a:ext cx="1665600" cy="124920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4353" y="1625729"/>
            <a:ext cx="1665600" cy="1249200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765242" y="1631308"/>
            <a:ext cx="1665600" cy="1249200"/>
          </a:xfrm>
          <a:prstGeom prst="rect">
            <a:avLst/>
          </a:prstGeom>
        </p:spPr>
      </p:pic>
      <p:graphicFrame>
        <p:nvGraphicFramePr>
          <p:cNvPr id="44" name="תרשים 4"/>
          <p:cNvGraphicFramePr>
            <a:graphicFrameLocks/>
          </p:cNvGraphicFramePr>
          <p:nvPr>
            <p:extLst/>
          </p:nvPr>
        </p:nvGraphicFramePr>
        <p:xfrm>
          <a:off x="7366819" y="2349670"/>
          <a:ext cx="4323035" cy="20025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pic>
        <p:nvPicPr>
          <p:cNvPr id="29" name="Picture 2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2091" y="316981"/>
            <a:ext cx="1665599" cy="1249200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5514353" y="316981"/>
            <a:ext cx="1665600" cy="1249200"/>
          </a:xfrm>
          <a:prstGeom prst="rect">
            <a:avLst/>
          </a:prstGeom>
        </p:spPr>
      </p:pic>
      <p:graphicFrame>
        <p:nvGraphicFramePr>
          <p:cNvPr id="49" name="Chart 48"/>
          <p:cNvGraphicFramePr>
            <a:graphicFrameLocks/>
          </p:cNvGraphicFramePr>
          <p:nvPr>
            <p:extLst/>
          </p:nvPr>
        </p:nvGraphicFramePr>
        <p:xfrm>
          <a:off x="7715250" y="316980"/>
          <a:ext cx="4029384" cy="2095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53" name="TextBox 52"/>
          <p:cNvSpPr txBox="1"/>
          <p:nvPr/>
        </p:nvSpPr>
        <p:spPr>
          <a:xfrm>
            <a:off x="11300127" y="597308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8" name="TextBox 57"/>
          <p:cNvSpPr txBox="1"/>
          <p:nvPr/>
        </p:nvSpPr>
        <p:spPr>
          <a:xfrm>
            <a:off x="10622148" y="599007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9" name="TextBox 58"/>
          <p:cNvSpPr txBox="1"/>
          <p:nvPr/>
        </p:nvSpPr>
        <p:spPr>
          <a:xfrm>
            <a:off x="9933248" y="631794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0" name="TextBox 59"/>
          <p:cNvSpPr txBox="1"/>
          <p:nvPr/>
        </p:nvSpPr>
        <p:spPr>
          <a:xfrm>
            <a:off x="9243147" y="1152140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1" name="TextBox 60"/>
          <p:cNvSpPr txBox="1"/>
          <p:nvPr/>
        </p:nvSpPr>
        <p:spPr>
          <a:xfrm>
            <a:off x="8559083" y="803080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2" name="TextBox 61"/>
          <p:cNvSpPr txBox="1"/>
          <p:nvPr/>
        </p:nvSpPr>
        <p:spPr>
          <a:xfrm>
            <a:off x="9905768" y="2616980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3" name="TextBox 62"/>
          <p:cNvSpPr txBox="1"/>
          <p:nvPr/>
        </p:nvSpPr>
        <p:spPr>
          <a:xfrm>
            <a:off x="8532837" y="4306985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4" name="TextBox 63"/>
          <p:cNvSpPr txBox="1"/>
          <p:nvPr/>
        </p:nvSpPr>
        <p:spPr>
          <a:xfrm>
            <a:off x="9210166" y="5003357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5" name="TextBox 64"/>
          <p:cNvSpPr txBox="1"/>
          <p:nvPr/>
        </p:nvSpPr>
        <p:spPr>
          <a:xfrm>
            <a:off x="9933248" y="5058428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6" name="TextBox 65"/>
          <p:cNvSpPr txBox="1"/>
          <p:nvPr/>
        </p:nvSpPr>
        <p:spPr>
          <a:xfrm>
            <a:off x="10622148" y="5056923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7" name="TextBox 66"/>
          <p:cNvSpPr txBox="1"/>
          <p:nvPr/>
        </p:nvSpPr>
        <p:spPr>
          <a:xfrm>
            <a:off x="11370080" y="4733757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68" name="TextBox 67"/>
          <p:cNvSpPr txBox="1"/>
          <p:nvPr/>
        </p:nvSpPr>
        <p:spPr>
          <a:xfrm>
            <a:off x="5514982" y="16877"/>
            <a:ext cx="166334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zuba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783888" y="16877"/>
            <a:ext cx="164741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rat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vi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1847838" y="761412"/>
            <a:ext cx="9244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nea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1691724" y="6038769"/>
            <a:ext cx="10695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atina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Rectangle 71"/>
          <p:cNvSpPr/>
          <p:nvPr/>
        </p:nvSpPr>
        <p:spPr>
          <a:xfrm>
            <a:off x="1569064" y="3362098"/>
            <a:ext cx="11807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roneiki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Rectangle 16"/>
          <p:cNvSpPr/>
          <p:nvPr/>
        </p:nvSpPr>
        <p:spPr>
          <a:xfrm>
            <a:off x="1658271" y="2044350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holine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Rectangle 20"/>
          <p:cNvSpPr/>
          <p:nvPr/>
        </p:nvSpPr>
        <p:spPr>
          <a:xfrm>
            <a:off x="2037405" y="4687591"/>
            <a:ext cx="7232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i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6" name="Group 75"/>
          <p:cNvGrpSpPr/>
          <p:nvPr/>
        </p:nvGrpSpPr>
        <p:grpSpPr>
          <a:xfrm>
            <a:off x="4651368" y="6408101"/>
            <a:ext cx="637253" cy="342056"/>
            <a:chOff x="4321483" y="6385481"/>
            <a:chExt cx="637253" cy="299129"/>
          </a:xfrm>
        </p:grpSpPr>
        <p:sp>
          <p:nvSpPr>
            <p:cNvPr id="77" name="TextBox 76"/>
            <p:cNvSpPr txBox="1"/>
            <p:nvPr/>
          </p:nvSpPr>
          <p:spPr>
            <a:xfrm>
              <a:off x="4321483" y="6385481"/>
              <a:ext cx="637253" cy="115165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µm</a:t>
              </a:r>
              <a:endParaRPr lang="he-I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8" name="Group 77"/>
            <p:cNvGrpSpPr/>
            <p:nvPr/>
          </p:nvGrpSpPr>
          <p:grpSpPr>
            <a:xfrm>
              <a:off x="4515590" y="6591906"/>
              <a:ext cx="254891" cy="92704"/>
              <a:chOff x="6642409" y="5175182"/>
              <a:chExt cx="254891" cy="92704"/>
            </a:xfrm>
          </p:grpSpPr>
          <p:cxnSp>
            <p:nvCxnSpPr>
              <p:cNvPr id="79" name="Straight Connector 78"/>
              <p:cNvCxnSpPr/>
              <p:nvPr/>
            </p:nvCxnSpPr>
            <p:spPr>
              <a:xfrm>
                <a:off x="6642409" y="5219701"/>
                <a:ext cx="25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6897300" y="5175182"/>
                <a:ext cx="0" cy="917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>
                <a:off x="6644958" y="5176090"/>
                <a:ext cx="0" cy="917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2" name="Group 81"/>
          <p:cNvGrpSpPr/>
          <p:nvPr/>
        </p:nvGrpSpPr>
        <p:grpSpPr>
          <a:xfrm>
            <a:off x="8532837" y="67145"/>
            <a:ext cx="3313511" cy="183069"/>
            <a:chOff x="8532837" y="67145"/>
            <a:chExt cx="3313511" cy="216024"/>
          </a:xfrm>
        </p:grpSpPr>
        <p:sp>
          <p:nvSpPr>
            <p:cNvPr id="83" name="TextBox 82"/>
            <p:cNvSpPr txBox="1"/>
            <p:nvPr/>
          </p:nvSpPr>
          <p:spPr>
            <a:xfrm>
              <a:off x="8851150" y="67145"/>
              <a:ext cx="2995198" cy="7588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2000" dirty="0" err="1">
                  <a:latin typeface="Times New Roman" pitchFamily="18" charset="0"/>
                  <a:cs typeface="Times New Roman" pitchFamily="18" charset="0"/>
                </a:rPr>
                <a:t>Tirat</a:t>
              </a:r>
              <a:r>
                <a:rPr lang="en-US" sz="2000" dirty="0">
                  <a:latin typeface="Times New Roman" pitchFamily="18" charset="0"/>
                  <a:cs typeface="Times New Roman" pitchFamily="18" charset="0"/>
                </a:rPr>
                <a:t>-Zvi               </a:t>
              </a:r>
              <a:r>
                <a:rPr lang="en-US" sz="2000" dirty="0" err="1">
                  <a:latin typeface="Times New Roman" pitchFamily="18" charset="0"/>
                  <a:cs typeface="Times New Roman" pitchFamily="18" charset="0"/>
                </a:rPr>
                <a:t>Tzuba</a:t>
              </a:r>
              <a:endParaRPr lang="he-IL" sz="20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4" name="Straight Connector 83"/>
            <p:cNvCxnSpPr/>
            <p:nvPr/>
          </p:nvCxnSpPr>
          <p:spPr>
            <a:xfrm flipH="1">
              <a:off x="8532837" y="283169"/>
              <a:ext cx="397893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 flipH="1">
              <a:off x="10396780" y="283169"/>
              <a:ext cx="397893" cy="0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54" name="תרשים 3"/>
          <p:cNvGraphicFramePr>
            <a:graphicFrameLocks/>
          </p:cNvGraphicFramePr>
          <p:nvPr>
            <p:extLst/>
          </p:nvPr>
        </p:nvGraphicFramePr>
        <p:xfrm>
          <a:off x="7366819" y="4268260"/>
          <a:ext cx="4479530" cy="20490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47" name="TextBox 46"/>
          <p:cNvSpPr txBox="1"/>
          <p:nvPr/>
        </p:nvSpPr>
        <p:spPr>
          <a:xfrm>
            <a:off x="8237310" y="6028159"/>
            <a:ext cx="751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ne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8885988" y="6033707"/>
            <a:ext cx="798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holin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9528413" y="6034051"/>
            <a:ext cx="868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roneiki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0905895" y="6032619"/>
            <a:ext cx="779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atin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0345688" y="6031872"/>
            <a:ext cx="560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i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6054" y="10298"/>
            <a:ext cx="2584624" cy="9541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endParaRPr 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8538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07</TotalTime>
  <Words>47</Words>
  <Application>Microsoft Office PowerPoint</Application>
  <PresentationFormat>Custom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ora Ben Ari</dc:creator>
  <cp:lastModifiedBy>Rajakumar</cp:lastModifiedBy>
  <cp:revision>114</cp:revision>
  <cp:lastPrinted>2019-07-09T06:55:45Z</cp:lastPrinted>
  <dcterms:created xsi:type="dcterms:W3CDTF">2018-03-06T07:50:21Z</dcterms:created>
  <dcterms:modified xsi:type="dcterms:W3CDTF">2020-04-14T17:34:52Z</dcterms:modified>
</cp:coreProperties>
</file>